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5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249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9321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5899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29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8538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154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1352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834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071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0703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2212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EB2E4-7CDE-4122-B9C3-1D97D67F7FD0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0C754-CBDC-44AF-A114-0B1AC55825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293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FF49A57-73C8-4964-9E71-FBF5D937C2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300" y="924560"/>
            <a:ext cx="5359400" cy="341215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D69C0A7-4540-469B-9254-6A577FF39A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300" y="4226560"/>
            <a:ext cx="5359400" cy="341215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1EB5C41-B1B6-4D71-9D96-2805D6303AA4}"/>
              </a:ext>
            </a:extLst>
          </p:cNvPr>
          <p:cNvSpPr txBox="1"/>
          <p:nvPr/>
        </p:nvSpPr>
        <p:spPr>
          <a:xfrm>
            <a:off x="749300" y="924561"/>
            <a:ext cx="335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A2E86AE-C719-4D8C-A3CE-0368A55859CD}"/>
              </a:ext>
            </a:extLst>
          </p:cNvPr>
          <p:cNvSpPr txBox="1"/>
          <p:nvPr/>
        </p:nvSpPr>
        <p:spPr>
          <a:xfrm>
            <a:off x="749300" y="4088060"/>
            <a:ext cx="335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18D538-DB24-4DC7-8708-88661D73FD85}"/>
              </a:ext>
            </a:extLst>
          </p:cNvPr>
          <p:cNvSpPr txBox="1"/>
          <p:nvPr/>
        </p:nvSpPr>
        <p:spPr>
          <a:xfrm>
            <a:off x="847344" y="7863840"/>
            <a:ext cx="52613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nalyses of the association between the genes and metabolites related to melatonin-mediated salt stress tolerance. The differentially regulated genes and differentially abundant metabolites in the two comparison groups (control </a:t>
            </a:r>
            <a:r>
              <a:rPr lang="en-US" altLang="zh-CN" sz="1200" i="1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s</a:t>
            </a:r>
            <a:r>
              <a:rPr lang="en-US" altLang="zh-CN" sz="1200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alt treatment and control </a:t>
            </a:r>
            <a:r>
              <a:rPr lang="en-US" altLang="zh-CN" sz="1200" i="1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s</a:t>
            </a:r>
            <a:r>
              <a:rPr lang="en-US" altLang="zh-CN" sz="1200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alt + melatonin treatment) were simultaneously mapped to KEGG pathways (p &lt; 0.05). (A) Enriched pathways for the salt + melatonin treatment. </a:t>
            </a:r>
            <a:r>
              <a:rPr lang="en-US" altLang="zh-CN" sz="1200" kern="12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B) Enriched pathways for the salt treatmen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4236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80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Fu-2019</dc:creator>
  <cp:lastModifiedBy>BFu-2019</cp:lastModifiedBy>
  <cp:revision>3</cp:revision>
  <dcterms:created xsi:type="dcterms:W3CDTF">2020-10-06T01:13:51Z</dcterms:created>
  <dcterms:modified xsi:type="dcterms:W3CDTF">2020-10-16T08:32:24Z</dcterms:modified>
</cp:coreProperties>
</file>